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5"/>
  </p:notesMasterIdLst>
  <p:handoutMasterIdLst>
    <p:handoutMasterId r:id="rId26"/>
  </p:handoutMasterIdLst>
  <p:sldIdLst>
    <p:sldId id="298" r:id="rId2"/>
    <p:sldId id="289" r:id="rId3"/>
    <p:sldId id="296" r:id="rId4"/>
    <p:sldId id="290" r:id="rId5"/>
    <p:sldId id="297" r:id="rId6"/>
    <p:sldId id="291" r:id="rId7"/>
    <p:sldId id="292" r:id="rId8"/>
    <p:sldId id="293" r:id="rId9"/>
    <p:sldId id="295" r:id="rId10"/>
    <p:sldId id="299" r:id="rId11"/>
    <p:sldId id="278" r:id="rId12"/>
    <p:sldId id="256" r:id="rId13"/>
    <p:sldId id="277" r:id="rId14"/>
    <p:sldId id="283" r:id="rId15"/>
    <p:sldId id="280" r:id="rId16"/>
    <p:sldId id="281" r:id="rId17"/>
    <p:sldId id="279" r:id="rId18"/>
    <p:sldId id="282" r:id="rId19"/>
    <p:sldId id="285" r:id="rId20"/>
    <p:sldId id="288" r:id="rId21"/>
    <p:sldId id="284" r:id="rId22"/>
    <p:sldId id="287" r:id="rId23"/>
    <p:sldId id="286" r:id="rId24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athryn McDonald" initials="K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243" autoAdjust="0"/>
  </p:normalViewPr>
  <p:slideViewPr>
    <p:cSldViewPr>
      <p:cViewPr>
        <p:scale>
          <a:sx n="100" d="100"/>
          <a:sy n="100" d="100"/>
        </p:scale>
        <p:origin x="-210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commentAuthors" Target="commentAuthors.xml"/><Relationship Id="rId30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97313" y="0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1F461C-D6F0-4E62-8BB3-EB7BB519C121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2982913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97313" y="8829675"/>
            <a:ext cx="2982912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D9F8B2-9AB1-4BA0-AC8A-4C64CA031C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0177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FAA77BA1-847A-40A6-B490-1A9E728B5AF9}" type="datetimeFigureOut">
              <a:rPr lang="en-US" smtClean="0"/>
              <a:t>7/2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176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C39C7E56-B838-4706-B38E-A93A3090D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680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18215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aseline="0" dirty="0" smtClean="0">
              <a:sym typeface="Wingdings" panose="05000000000000000000" pitchFamily="2" charset="2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11046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961138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08140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04057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40639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83790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407913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073450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007309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74814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7460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38147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4793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39884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28143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64436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48469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39C7E56-B838-4706-B38E-A93A3090D044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7599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RT I: Vulnerabilities Experienced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8 slides: 40 vulnerabilities</a:t>
            </a:r>
          </a:p>
          <a:p>
            <a:r>
              <a:rPr lang="en-US" dirty="0" smtClean="0"/>
              <a:t>Check any that you believe apply to your clinic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83850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PART II: Solutions to Vulnerabilities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13 Slides: 13 solution attributes</a:t>
            </a:r>
          </a:p>
          <a:p>
            <a:r>
              <a:rPr lang="en-US" dirty="0" smtClean="0"/>
              <a:t>Read and then respond to statements at bottom</a:t>
            </a:r>
          </a:p>
          <a:p>
            <a:r>
              <a:rPr lang="en-US" dirty="0" smtClean="0"/>
              <a:t>Sort as you go to prioritize most important to least important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271804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1633478"/>
            <a:ext cx="7664943" cy="2862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opulation registry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unctionality for high-risk patien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erves as a functional list of patients for population manage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Use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visualization/ sorting to quickly identify patients in need of follow-up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Uses prioritization to identify highest risk patients firs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erges different sources of information needed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or case identification and referral tracking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roups patients by PCP (or lack of PCP)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1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295400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3401" y="304800"/>
            <a:ext cx="533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Our clinic needs an accurate list of all patients that need monitoring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9101665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out what patients are “on the list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s patients who have similar care pathway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roups patients by similar condition/ treatment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implifies monitoring pathway for operational effectivenes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2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Our patients can be grouped according to follow-up needs and urgency level required to monitor appropriately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4399268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ustomize the patient list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pture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data unique to each pati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llows for customizatio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3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56259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I don’t want to have to go back and forth between the list and each individual patient’s record to figure out what they need next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4263583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93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eeps list up-to-dat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Updates tracking list automatically with relevant information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rom EHR,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ther system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Updates in real-ti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llows for manual input when frontline knowledge of patients is more accurate than system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4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I don’t want a list with incorrect information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443679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bility to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ata acces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rovides clinicians with ability to share work to limit redundancy/ miss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mplies with HIPA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5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We need the list accessible at the point that it is needed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9438255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cheduling functional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elps clinical team and support staf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oordinat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cheduling-related challeng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nalyze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atterns o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cheduling challenges such as no show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6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Our clinic staff has to deal with a myriad of scheduling challenges related to monitoring our patients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753287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63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sign roles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d responsibiliti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ssigns responsibility for each monitoring task, even for rotating personnel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rovides time to carry out roles related to monitor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hows the team what activities are completed versus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ending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7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Our clinic has multiple people involved in monitoring our high-risk patients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3044452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riggered 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tifications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ushes out notifications for monitoring to appropriate care team members based on customizable rul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Offers calendar integration for notification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8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We need know when a patient needs monitoring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586576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1478101"/>
            <a:ext cx="7664943" cy="2862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atient suppor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p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ailor appointment planning to patient preferences, needs, vulnerabilities (e.g. lack of transportation, interacting comorbidities like substance use, language interpretation needs, insurance eligibility, etc.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ives clinicians ability to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hange care plan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ased on their clinical judg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Helps care team identify and loop in needed patient support (e.g. health care workers, social workers, counselors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19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143000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We have to consider our patients’ unique circumstances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1135779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always know which patients need to be called back for monitoring 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Outside of visit-based care, don’t always know when patients need follow-up monitoring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Looking up each patient’s information takes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ime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Have to track some patients in own mind or side system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Hav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o spend too much time scheduling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Don’t know what types of scheduling challenges occur most often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 smtClean="0"/>
              <a:t>Check any that apply</a:t>
            </a:r>
            <a:endParaRPr lang="en-US" sz="4000" dirty="0"/>
          </a:p>
        </p:txBody>
      </p:sp>
    </p:spTree>
    <p:extLst>
      <p:ext uri="{BB962C8B-B14F-4D97-AF65-F5344CB8AC3E}">
        <p14:creationId xmlns:p14="http://schemas.microsoft.com/office/powerpoint/2010/main" val="1976701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1371600"/>
            <a:ext cx="7664943" cy="25545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lete patient information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ather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nd uses provider preferences for communication and cadence of communicat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ovides the amount of detail provider need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llow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ccess to entire care plan as needed by role (i.e. panel managers, PCPs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Gives PCP overview of patients monitored by each specialty clini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0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990600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6324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Multiple providers need to know about patients being monitored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641083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32343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tandardized data entr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Provides standardized data fields for consistent data collectio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Prompts documentation o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ny clinical decisions made for complete data collection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1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Differences in documenting information pertinent to monitoring options can make it hard to tell what the patient needs next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90101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93899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omplete data captur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lags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issing information and identifies where data is likely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issing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ps fill gaps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upports users knowing where to look, and being empowered to surface questions when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can’t find needed data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2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6096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It can be hard to distinguish between missing data and missing care (e.g., test result not available versus test not done).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039866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50743" y="148803"/>
            <a:ext cx="597306" cy="55226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85800" y="2072908"/>
            <a:ext cx="7664943" cy="1631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erformance dat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Captures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data on missed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monitoring in a clinically and operationally relevant wa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Estimates impact of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missed monitoring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help make 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system improvement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09600" y="5334001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contribute to improved monitoring in my clini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600" y="6096000"/>
            <a:ext cx="2514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is solution will reduce time spent monitoring high-risk patient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685800" y="5943600"/>
            <a:ext cx="7467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24200" y="5334001"/>
            <a:ext cx="0" cy="12953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093027" y="4778623"/>
            <a:ext cx="1066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234180" y="4829441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18347" y="4752496"/>
            <a:ext cx="1391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ITHER AGREE NOR DIS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381981" y="485556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7219840" y="4730776"/>
            <a:ext cx="11891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RONGLY AG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6491201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4415905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5442527" y="5256151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3385820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7552807" y="5268749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5442527" y="613016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4419600" y="61356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6501592" y="614588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3385820" y="5255678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7542649" y="6120190"/>
            <a:ext cx="543560" cy="509210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Slide Number Placeholder 2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3</a:t>
            </a:fld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070239" y="1684526"/>
            <a:ext cx="30029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OLUTION ATTRIBUT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715821" y="148803"/>
            <a:ext cx="16536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ANK IN ORDER OF IMPORTANCE (1-13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3400" y="304800"/>
            <a:ext cx="5867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“It would be useful to know the scope of the missed monitoring problem.”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2408593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4000" dirty="0"/>
              <a:t>Check any that appl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ave a system to put patients into subgroups for more efficient monitoring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Hard to stratif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atients into subgroups for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monitoring due to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any individual patien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reat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list of patients requiring monitoring takes time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aintain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list of patients requiring monitoring takes time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anually monitor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atients is error-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rone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anuall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monitoring patients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is tim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ntensiv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36598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Lis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 we use outdates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quickly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Inefficient system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to create personal, </a:t>
            </a:r>
            <a:r>
              <a:rPr lang="en-US" sz="2400" dirty="0" err="1">
                <a:latin typeface="Arial" panose="020B0604020202020204" pitchFamily="34" charset="0"/>
                <a:cs typeface="Arial" panose="020B0604020202020204" pitchFamily="34" charset="0"/>
              </a:rPr>
              <a:t>siloed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reminders for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follow-up 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lways wan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lert when patient status change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have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dequate real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-time data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edi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’s car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athway as needed based on frontline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 Can’t divert alerts to other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rovider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spcBef>
                <a:spcPts val="1104"/>
              </a:spcBef>
              <a:buNone/>
            </a:pPr>
            <a:endParaRPr lang="en-US" sz="2400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Check any that apply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9289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dirty="0"/>
              <a:t>Check any that appl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know when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 data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is missing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nd missing data within clinic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find missing data from outside clinic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Analyz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ata in ad hoc manner is time intensive 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Analyz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ata in ad hoc manner is error-prone</a:t>
            </a:r>
          </a:p>
          <a:p>
            <a:pPr>
              <a:spcBef>
                <a:spcPts val="110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use patient data for operational improvement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734655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r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lan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is poorly documented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Systems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on’t talk to each other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Everyone inputs data differently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an’t share patient list with entire care team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lways have the time to perform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ssigned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role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Coordinat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cheduling efforts across care teams is difficult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dirty="0"/>
              <a:t>Check any that apply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532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Unaware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of clinic’s performance in patien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monitoring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Know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who is managing at each stage is unclear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Overlapping efforts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always know when the loop closes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Mapp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atient to care plan requires clinical judgment</a:t>
            </a:r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/>
              <a:t>Check any that appl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8022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Little or no performance data about monitoring so don’t know where to focus any improvement effort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Inconsisten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rocess for informing PCP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Involving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PCP when no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necessary</a:t>
            </a: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PCP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doesn’t have overview of all patient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info/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are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176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know when patient changes </a:t>
            </a: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status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en-US" dirty="0"/>
              <a:t>Check any that apply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793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>
              <a:spcBef>
                <a:spcPts val="122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ifficulty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ommunicating patient needs with entire care team</a:t>
            </a:r>
          </a:p>
          <a:p>
            <a:pPr>
              <a:spcBef>
                <a:spcPts val="122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always know patient’s vulnerabilities relevant to monitoring (e.g. patient’s work schedule, can’t get to clinic, substance abuse)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Bef>
                <a:spcPts val="122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Stretched for resources to reach out to all patients in need of follow-up </a:t>
            </a:r>
          </a:p>
          <a:p>
            <a:pPr>
              <a:spcBef>
                <a:spcPts val="122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lways know when patient doesn’t have PCP</a:t>
            </a:r>
          </a:p>
          <a:p>
            <a:pPr>
              <a:spcBef>
                <a:spcPts val="1224"/>
              </a:spcBef>
              <a:buFont typeface="Wingdings" charset="2"/>
              <a:buChar char=""/>
            </a:pPr>
            <a:r>
              <a:rPr lang="en-US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Don’t </a:t>
            </a:r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know when patient misses appointment</a:t>
            </a:r>
          </a:p>
          <a:p>
            <a:endParaRPr lang="en-US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en-US" sz="4000" dirty="0"/>
              <a:t>Check any that apply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50634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1</TotalTime>
  <Words>1680</Words>
  <Application>Microsoft Office PowerPoint</Application>
  <PresentationFormat>On-screen Show (4:3)</PresentationFormat>
  <Paragraphs>272</Paragraphs>
  <Slides>23</Slides>
  <Notes>19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Theme</vt:lpstr>
      <vt:lpstr>PART I: Vulnerabilities Experienced</vt:lpstr>
      <vt:lpstr>Check any that apply</vt:lpstr>
      <vt:lpstr>Check any that apply</vt:lpstr>
      <vt:lpstr>Check any that apply</vt:lpstr>
      <vt:lpstr>Check any that apply</vt:lpstr>
      <vt:lpstr>Check any that apply</vt:lpstr>
      <vt:lpstr>Check any that apply</vt:lpstr>
      <vt:lpstr>Check any that apply</vt:lpstr>
      <vt:lpstr>Check any that apply</vt:lpstr>
      <vt:lpstr>PART II: Solutions to Vulnerabilitie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sker, Sarah</dc:creator>
  <cp:lastModifiedBy>Sarah Lisker</cp:lastModifiedBy>
  <cp:revision>53</cp:revision>
  <cp:lastPrinted>2016-04-18T18:58:07Z</cp:lastPrinted>
  <dcterms:created xsi:type="dcterms:W3CDTF">2006-08-16T00:00:00Z</dcterms:created>
  <dcterms:modified xsi:type="dcterms:W3CDTF">2016-07-20T22:48:48Z</dcterms:modified>
</cp:coreProperties>
</file>